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F0CBD3-D368-4E17-A643-903504F56EF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7789E9-930E-4157-A986-3C70DC48242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45F502-E526-4030-9CBC-026A04E119C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0D62F2-0D2C-4220-BA85-9DE4C6F4124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6C1165-2CEE-4351-A6B7-438FFDFCE7A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EE4B69-E97D-473F-A2F0-CD804871C7C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456211-A1A9-4C39-8056-1F256741FB7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04E9A5-C312-415F-93A0-3998F474B30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458247-C97D-4B85-8CD2-63451B00741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581449-37B3-4F3C-8821-D6BE3F7B9B7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9FBF5D-CAAE-4396-892F-26C04C7BC5E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4EA108-14FD-4AFB-8BA1-91AAA913FA8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F1B30DC-66F9-4734-B7BA-B8031558A108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962000" y="2163600"/>
          <a:ext cx="5221440" cy="2530800"/>
        </p:xfrm>
        <a:graphic>
          <a:graphicData uri="http://schemas.openxmlformats.org/drawingml/2006/table">
            <a:tbl>
              <a:tblPr/>
              <a:tblGrid>
                <a:gridCol w="1394640"/>
                <a:gridCol w="173520"/>
                <a:gridCol w="1247760"/>
                <a:gridCol w="1693080"/>
                <a:gridCol w="712440"/>
              </a:tblGrid>
              <a:tr h="397080">
                <a:tc gridSpan="4">
                  <a:txBody>
                    <a:bodyPr lIns="68760" rIns="687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able S1 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SSQ domain scores on POD 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44080">
                <a:tc>
                  <a:txBody>
                    <a:bodyPr lIns="68760" rIns="68760" anchor="ctr">
                      <a:noAutofit/>
                    </a:bodyPr>
                    <a:p>
                      <a:pPr algn="ctr">
                        <a:lnSpc>
                          <a:spcPts val="11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 lIns="68760" rIns="68760" anchor="ctr">
                      <a:noAutofit/>
                    </a:bodyPr>
                    <a:p>
                      <a:pPr algn="ctr">
                        <a:lnSpc>
                          <a:spcPts val="11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trin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8760" rIns="68760" anchor="ctr">
                      <a:noAutofit/>
                    </a:bodyPr>
                    <a:p>
                      <a:pPr algn="ctr">
                        <a:lnSpc>
                          <a:spcPts val="11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n-strin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 lIns="68760" rIns="68760" anchor="ctr">
                      <a:noAutofit/>
                    </a:bodyPr>
                    <a:p>
                      <a:pPr algn="ctr">
                        <a:lnSpc>
                          <a:spcPts val="11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44440">
                <a:tc>
                  <a:txBody>
                    <a:bodyPr lIns="68760" rIns="68760" anchor="ctr">
                      <a:noAutofit/>
                    </a:bodyPr>
                    <a:p>
                      <a:pPr algn="ctr">
                        <a:lnSpc>
                          <a:spcPts val="11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 lIns="68760" rIns="68760" anchor="ctr">
                      <a:noAutofit/>
                    </a:bodyPr>
                    <a:p>
                      <a:pPr algn="ctr">
                        <a:lnSpc>
                          <a:spcPts val="11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Mean ± SD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8760" rIns="68760" anchor="ctr">
                      <a:noAutofit/>
                    </a:bodyPr>
                    <a:p>
                      <a:pPr algn="ctr">
                        <a:lnSpc>
                          <a:spcPts val="1199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Mean ± SD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74680">
                <a:tc gridSpan="2">
                  <a:txBody>
                    <a:bodyPr lIns="68760" rIns="687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rinary Symptom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8760" rIns="6876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7.15±3.2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6.44±2.9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1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74320">
                <a:tc gridSpan="2">
                  <a:txBody>
                    <a:bodyPr lIns="68760" rIns="687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ai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8760" rIns="6876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8.75±4.4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7.53±4.5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1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73240">
                <a:tc gridSpan="2">
                  <a:txBody>
                    <a:bodyPr lIns="68760" rIns="687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eneral Health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8760" rIns="6876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.68±4.5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.12±4.3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4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74680">
                <a:tc gridSpan="2">
                  <a:txBody>
                    <a:bodyPr lIns="68760" rIns="687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Work Performanc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8760" rIns="6876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.95±3.9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79±3.6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74680">
                <a:tc gridSpan="2">
                  <a:txBody>
                    <a:bodyPr lIns="68760" rIns="687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x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8760" rIns="6876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03±3.6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14±2.5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1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73600">
                <a:tc gridSpan="2">
                  <a:txBody>
                    <a:bodyPr lIns="68760" rIns="687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dditional Problem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8760" rIns="6876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.69±2.7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.11±2.3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1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2" name=""/>
          <p:cNvGraphicFramePr/>
          <p:nvPr/>
        </p:nvGraphicFramePr>
        <p:xfrm>
          <a:off x="2106720" y="2133720"/>
          <a:ext cx="4930560" cy="2590560"/>
        </p:xfrm>
        <a:graphic>
          <a:graphicData uri="http://schemas.openxmlformats.org/drawingml/2006/table">
            <a:tbl>
              <a:tblPr/>
              <a:tblGrid>
                <a:gridCol w="1620720"/>
                <a:gridCol w="1170000"/>
                <a:gridCol w="1258920"/>
                <a:gridCol w="880920"/>
              </a:tblGrid>
              <a:tr h="378720">
                <a:tc gridSpan="4">
                  <a:txBody>
                    <a:bodyPr lIns="68400" rIns="684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able S2 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SSQ domain scores before stent remova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76480">
                <a:tc>
                  <a:txBody>
                    <a:bodyPr lIns="68400" rIns="684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trin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n-strin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 lIns="68400" rIns="684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76480">
                <a:tc>
                  <a:txBody>
                    <a:bodyPr lIns="68400" rIns="684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Mean ± SD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Mean ± SD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76480">
                <a:tc>
                  <a:txBody>
                    <a:bodyPr lIns="68400" rIns="684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rinary Symptom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5.95±4.8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4.88±4.4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19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76480">
                <a:tc>
                  <a:txBody>
                    <a:bodyPr lIns="68400" rIns="684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ai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.34±4.7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.18±4.6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50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76480">
                <a:tc>
                  <a:txBody>
                    <a:bodyPr lIns="68400" rIns="684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eneral Health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.78±5.1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.39±4.5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65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76480">
                <a:tc>
                  <a:txBody>
                    <a:bodyPr lIns="68400" rIns="684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Work Performanc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.40±2.6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.02±2.5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39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76480">
                <a:tc>
                  <a:txBody>
                    <a:bodyPr lIns="68400" rIns="684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x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34±2.8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23±2.2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1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76480">
                <a:tc>
                  <a:txBody>
                    <a:bodyPr lIns="68400" rIns="684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dditional Problem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.11±2.1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89±1.7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54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2-11-21T13:48:54Z</dcterms:created>
  <dc:creator>祁元炯</dc:creator>
  <dc:description/>
  <dc:language>en-US</dc:language>
  <cp:lastModifiedBy>祁 元炯</cp:lastModifiedBy>
  <dcterms:modified xsi:type="dcterms:W3CDTF">2022-12-08T08:16:20Z</dcterms:modified>
  <cp:revision>5</cp:revision>
  <dc:subject/>
  <dc:title>PowerPoint 演示文稿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9479B8E3D44E44D8949AECE2EFFF429C</vt:lpwstr>
  </property>
  <property fmtid="{D5CDD505-2E9C-101B-9397-08002B2CF9AE}" pid="3" name="KSOProductBuildVer">
    <vt:lpwstr>2052-11.1.0.12763</vt:lpwstr>
  </property>
</Properties>
</file>